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12193588"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0EA829E-0A87-4812-BE19-821F89862A14}"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F6A965A2-BAEF-4ED8-AAD2-60F6A27646B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1FDB541-59A9-4646-98F0-6BCD2234BDF2}"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B52E9CC-38DF-4179-9092-C7FF5046059E}"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3E6D159-F613-4AF8-A15D-75794A8291A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C3DC930-3994-4693-ABAC-85B75D1E844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8899498-C244-454E-8782-26789462ECB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3782AB0-F412-4BE3-BF74-A8A3955BF55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1E5D1D1-CBA2-434F-B344-19979E6C7B3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3858B98-6EE2-4F8B-B487-59FA06EF74F5}"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C2FFBC0-66D0-48DB-987C-468752BD186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255F52F-DD43-4D44-B093-2C5F5676D53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9DBF090-367F-479F-A044-9D02AAFBDDC2}" type="slidenum">
              <a:rPr b="0" lang="en-U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image" Target="../media/image3.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itle 1"/>
          <p:cNvSpPr/>
          <p:nvPr/>
        </p:nvSpPr>
        <p:spPr>
          <a:xfrm>
            <a:off x="55440" y="84240"/>
            <a:ext cx="12136680" cy="1371600"/>
          </a:xfrm>
          <a:prstGeom prst="rect">
            <a:avLst/>
          </a:prstGeom>
          <a:noFill/>
          <a:ln w="0">
            <a:noFill/>
          </a:ln>
        </p:spPr>
        <p:style>
          <a:lnRef idx="0"/>
          <a:fillRef idx="0"/>
          <a:effectRef idx="0"/>
          <a:fontRef idx="minor"/>
        </p:style>
        <p:txBody>
          <a:bodyPr lIns="90000" rIns="90000" tIns="46800" bIns="46800" anchor="t">
            <a:noAutofit/>
          </a:bodyPr>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ea typeface="Arial"/>
              </a:rPr>
              <a:t>Figure S1: Gene importance plot derived from Variable/ Feature selection using machine learning on the training dataset. </a:t>
            </a:r>
            <a:endParaRPr b="0" lang="en-US" sz="1600" spc="-1" strike="noStrike">
              <a:solidFill>
                <a:srgbClr val="000000"/>
              </a:solidFill>
              <a:latin typeface="Calibri"/>
            </a:endParaRPr>
          </a:p>
          <a:p>
            <a:pPr>
              <a:lnSpc>
                <a:spcPct val="9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ea typeface="Arial"/>
              </a:rPr>
              <a:t>MeanDecreaseGini is the measure of gene importance for training dataset.</a:t>
            </a:r>
            <a:endParaRPr b="0" lang="en-US" sz="1600" spc="-1" strike="noStrike">
              <a:solidFill>
                <a:srgbClr val="000000"/>
              </a:solidFill>
              <a:latin typeface="Calibri"/>
            </a:endParaRPr>
          </a:p>
        </p:txBody>
      </p:sp>
      <p:pic>
        <p:nvPicPr>
          <p:cNvPr id="42" name="Picture 4" descr=""/>
          <p:cNvPicPr/>
          <p:nvPr/>
        </p:nvPicPr>
        <p:blipFill>
          <a:blip r:embed="rId1"/>
          <a:stretch/>
        </p:blipFill>
        <p:spPr>
          <a:xfrm>
            <a:off x="4483080" y="770040"/>
            <a:ext cx="3281400" cy="5837040"/>
          </a:xfrm>
          <a:prstGeom prst="rect">
            <a:avLst/>
          </a:prstGeom>
          <a:ln w="9360">
            <a:solidFill>
              <a:srgbClr val="000000"/>
            </a:solidFill>
            <a:miter/>
          </a:ln>
        </p:spPr>
      </p:pic>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3" name="TextBox 4"/>
          <p:cNvSpPr/>
          <p:nvPr/>
        </p:nvSpPr>
        <p:spPr>
          <a:xfrm>
            <a:off x="235080" y="1187280"/>
            <a:ext cx="60814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44" name="TextBox 5"/>
          <p:cNvSpPr/>
          <p:nvPr/>
        </p:nvSpPr>
        <p:spPr>
          <a:xfrm>
            <a:off x="6316560" y="1157400"/>
            <a:ext cx="24494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pic>
        <p:nvPicPr>
          <p:cNvPr id="45" name="Picture 7" descr=""/>
          <p:cNvPicPr/>
          <p:nvPr/>
        </p:nvPicPr>
        <p:blipFill>
          <a:blip r:embed="rId1"/>
          <a:srcRect l="2517" t="3204" r="1604" b="3046"/>
          <a:stretch/>
        </p:blipFill>
        <p:spPr>
          <a:xfrm>
            <a:off x="641520" y="1341360"/>
            <a:ext cx="5478120" cy="5470560"/>
          </a:xfrm>
          <a:prstGeom prst="rect">
            <a:avLst/>
          </a:prstGeom>
          <a:ln w="9360">
            <a:solidFill>
              <a:srgbClr val="000000"/>
            </a:solidFill>
            <a:miter/>
          </a:ln>
        </p:spPr>
      </p:pic>
      <p:pic>
        <p:nvPicPr>
          <p:cNvPr id="46" name="Picture 8" descr=""/>
          <p:cNvPicPr/>
          <p:nvPr/>
        </p:nvPicPr>
        <p:blipFill>
          <a:blip r:embed="rId2"/>
          <a:srcRect l="4920" t="16591" r="35919" b="6004"/>
          <a:stretch/>
        </p:blipFill>
        <p:spPr>
          <a:xfrm>
            <a:off x="6529320" y="1596960"/>
            <a:ext cx="5373720" cy="4651560"/>
          </a:xfrm>
          <a:prstGeom prst="rect">
            <a:avLst/>
          </a:prstGeom>
          <a:ln w="9360">
            <a:solidFill>
              <a:srgbClr val="000000"/>
            </a:solidFill>
            <a:miter/>
          </a:ln>
        </p:spPr>
      </p:pic>
      <p:sp>
        <p:nvSpPr>
          <p:cNvPr id="47" name="TextBox 7"/>
          <p:cNvSpPr/>
          <p:nvPr/>
        </p:nvSpPr>
        <p:spPr>
          <a:xfrm>
            <a:off x="84240" y="65160"/>
            <a:ext cx="11993400" cy="10674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Calibri"/>
              </a:rPr>
              <a:t>Figure S2. Ingenuity Pathway analysis showing the prediction of the a) top network and b) top upstream regulator based on the 42-gene signature of PI-response. </a:t>
            </a:r>
            <a:endParaRPr b="0" lang="en-US" sz="1600" spc="-1" strike="noStrike">
              <a:solidFill>
                <a:srgbClr val="000000"/>
              </a:solidFill>
              <a:latin typeface="Calibri"/>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Calibri"/>
              </a:rPr>
              <a:t>Gene nodes are displayed using various shapes denoting the functional class of the gene product. Green symbolizes downregulation of gene expression, while red represents upregulation of gene expression. The significance of up/down-regulation is represented by color intensity. </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8-30T19:01:45Z</dcterms:created>
  <dc:creator>Amit K Mitra</dc:creator>
  <dc:description/>
  <dc:language>en-US</dc:language>
  <cp:lastModifiedBy>vidya.p</cp:lastModifiedBy>
  <dcterms:modified xsi:type="dcterms:W3CDTF">2017-06-30T11:38:38Z</dcterms:modified>
  <cp:revision>2</cp:revision>
  <dc:subject/>
  <dc:title>PowerPoint Presentation</dc:title>
</cp:coreProperties>
</file>